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DEB793B-9795-4BB9-B1C2-CDEB9952E7F2}">
          <p14:sldIdLst>
            <p14:sldId id="256"/>
          </p14:sldIdLst>
        </p14:section>
        <p14:section name="Untitled Section" id="{0E4C0409-7B6F-4F0F-9A4F-2D8C5AA81FF7}">
          <p14:sldIdLst/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-1350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5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09396" y="457041"/>
            <a:ext cx="360040" cy="1082527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Identifying practice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3194974" y="457487"/>
            <a:ext cx="1584176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312 practices invited to join the study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194974" y="1279340"/>
            <a:ext cx="1584176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343 practices randomised at baseline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1178751" y="457487"/>
            <a:ext cx="1584176" cy="144016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36 excluded: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9 limited resources (Denmark)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3 allocated to pilot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(Cambridge)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5 in no screening arm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(Cambridge)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9 no search possible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(Leicester)</a:t>
            </a:r>
          </a:p>
        </p:txBody>
      </p:sp>
      <p:sp>
        <p:nvSpPr>
          <p:cNvPr id="8" name="Rectangle 7"/>
          <p:cNvSpPr/>
          <p:nvPr/>
        </p:nvSpPr>
        <p:spPr>
          <a:xfrm>
            <a:off x="2042847" y="2041663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76 practices randomises to routine care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4203087" y="2041663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67 practices randomised to provide intensive treatment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2042847" y="3454439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57 practices identified patients by 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4203087" y="3454439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61 practices identified patients by 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1502786" y="2617725"/>
            <a:ext cx="1080120" cy="712739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9 excluded: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1 withdrew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8 screened but no diabetes patients found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657172" y="2607705"/>
            <a:ext cx="1080120" cy="712739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6 excluded: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5 withdrew</a:t>
            </a:r>
          </a:p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 screened but no diabetes patients found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2042847" y="4038887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smtClean="0">
                <a:solidFill>
                  <a:schemeClr val="tx1"/>
                </a:solidFill>
              </a:rPr>
              <a:t>1379 </a:t>
            </a:r>
            <a:r>
              <a:rPr lang="en-GB" sz="900" dirty="0" smtClean="0">
                <a:solidFill>
                  <a:schemeClr val="tx1"/>
                </a:solidFill>
              </a:rPr>
              <a:t>patients identified by 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205182" y="4038887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678 patients identified by 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042847" y="5210015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287 eligible for primary 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4203087" y="5210015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574 eligible for primary 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2042847" y="5794463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937 with complete information for primary 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4205182" y="5794463"/>
            <a:ext cx="1800200" cy="432048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164 with complete information for primary 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1430778" y="4633949"/>
            <a:ext cx="1080120" cy="428651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92 died during follow up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627022" y="4633949"/>
            <a:ext cx="1080120" cy="428651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104 died during follow up</a:t>
            </a:r>
            <a:endParaRPr lang="en-GB" sz="900" dirty="0">
              <a:solidFill>
                <a:schemeClr val="tx1"/>
              </a:solidFill>
            </a:endParaRPr>
          </a:p>
        </p:txBody>
      </p:sp>
      <p:cxnSp>
        <p:nvCxnSpPr>
          <p:cNvPr id="22" name="Straight Arrow Connector 21"/>
          <p:cNvCxnSpPr>
            <a:stCxn id="5" idx="2"/>
            <a:endCxn id="6" idx="0"/>
          </p:cNvCxnSpPr>
          <p:nvPr/>
        </p:nvCxnSpPr>
        <p:spPr>
          <a:xfrm>
            <a:off x="3987062" y="889534"/>
            <a:ext cx="0" cy="389807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stCxn id="6" idx="2"/>
            <a:endCxn id="8" idx="0"/>
          </p:cNvCxnSpPr>
          <p:nvPr/>
        </p:nvCxnSpPr>
        <p:spPr>
          <a:xfrm flipH="1">
            <a:off x="2942947" y="1711388"/>
            <a:ext cx="1044116" cy="330275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>
            <a:stCxn id="6" idx="2"/>
            <a:endCxn id="9" idx="0"/>
          </p:cNvCxnSpPr>
          <p:nvPr/>
        </p:nvCxnSpPr>
        <p:spPr>
          <a:xfrm>
            <a:off x="3987063" y="1711388"/>
            <a:ext cx="1116124" cy="330275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>
            <a:stCxn id="8" idx="2"/>
            <a:endCxn id="10" idx="0"/>
          </p:cNvCxnSpPr>
          <p:nvPr/>
        </p:nvCxnSpPr>
        <p:spPr>
          <a:xfrm>
            <a:off x="2942946" y="2473711"/>
            <a:ext cx="0" cy="98072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>
            <a:stCxn id="9" idx="2"/>
            <a:endCxn id="11" idx="0"/>
          </p:cNvCxnSpPr>
          <p:nvPr/>
        </p:nvCxnSpPr>
        <p:spPr>
          <a:xfrm>
            <a:off x="5103186" y="2473711"/>
            <a:ext cx="0" cy="98072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>
            <a:endCxn id="12" idx="3"/>
          </p:cNvCxnSpPr>
          <p:nvPr/>
        </p:nvCxnSpPr>
        <p:spPr>
          <a:xfrm flipH="1">
            <a:off x="2582907" y="2974095"/>
            <a:ext cx="3600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 flipH="1">
            <a:off x="4743147" y="2948745"/>
            <a:ext cx="360040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>
            <a:stCxn id="10" idx="2"/>
            <a:endCxn id="14" idx="0"/>
          </p:cNvCxnSpPr>
          <p:nvPr/>
        </p:nvCxnSpPr>
        <p:spPr>
          <a:xfrm>
            <a:off x="2942946" y="3886487"/>
            <a:ext cx="0" cy="1524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>
            <a:stCxn id="11" idx="2"/>
            <a:endCxn id="15" idx="0"/>
          </p:cNvCxnSpPr>
          <p:nvPr/>
        </p:nvCxnSpPr>
        <p:spPr>
          <a:xfrm>
            <a:off x="5103187" y="3886487"/>
            <a:ext cx="2096" cy="1524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>
            <a:stCxn id="14" idx="2"/>
            <a:endCxn id="16" idx="0"/>
          </p:cNvCxnSpPr>
          <p:nvPr/>
        </p:nvCxnSpPr>
        <p:spPr>
          <a:xfrm>
            <a:off x="2942946" y="4470935"/>
            <a:ext cx="0" cy="73908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>
            <a:stCxn id="15" idx="2"/>
            <a:endCxn id="17" idx="0"/>
          </p:cNvCxnSpPr>
          <p:nvPr/>
        </p:nvCxnSpPr>
        <p:spPr>
          <a:xfrm flipH="1">
            <a:off x="5103187" y="4470935"/>
            <a:ext cx="2096" cy="73908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>
            <a:stCxn id="16" idx="2"/>
            <a:endCxn id="18" idx="0"/>
          </p:cNvCxnSpPr>
          <p:nvPr/>
        </p:nvCxnSpPr>
        <p:spPr>
          <a:xfrm>
            <a:off x="2942946" y="5642063"/>
            <a:ext cx="0" cy="1524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stCxn id="17" idx="2"/>
            <a:endCxn id="19" idx="0"/>
          </p:cNvCxnSpPr>
          <p:nvPr/>
        </p:nvCxnSpPr>
        <p:spPr>
          <a:xfrm>
            <a:off x="5103187" y="5642063"/>
            <a:ext cx="2096" cy="15240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>
            <a:endCxn id="20" idx="3"/>
          </p:cNvCxnSpPr>
          <p:nvPr/>
        </p:nvCxnSpPr>
        <p:spPr>
          <a:xfrm flipH="1">
            <a:off x="2510898" y="4848275"/>
            <a:ext cx="432048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>
            <a:endCxn id="21" idx="3"/>
          </p:cNvCxnSpPr>
          <p:nvPr/>
        </p:nvCxnSpPr>
        <p:spPr>
          <a:xfrm flipH="1">
            <a:off x="4707142" y="4848275"/>
            <a:ext cx="397092" cy="0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Rectangle 36"/>
          <p:cNvSpPr/>
          <p:nvPr/>
        </p:nvSpPr>
        <p:spPr>
          <a:xfrm>
            <a:off x="609396" y="1539567"/>
            <a:ext cx="360040" cy="1510208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Allocation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609396" y="3049775"/>
            <a:ext cx="360040" cy="142116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Screening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609396" y="4470935"/>
            <a:ext cx="360040" cy="710580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Follow up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609396" y="5181515"/>
            <a:ext cx="360040" cy="1044996"/>
          </a:xfrm>
          <a:prstGeom prst="rect">
            <a:avLst/>
          </a:prstGeom>
          <a:solidFill>
            <a:schemeClr val="bg1">
              <a:lumMod val="9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/>
          <a:p>
            <a:pPr algn="ctr"/>
            <a:r>
              <a:rPr lang="en-GB" sz="900" dirty="0" smtClean="0">
                <a:solidFill>
                  <a:schemeClr val="tx1"/>
                </a:solidFill>
              </a:rPr>
              <a:t>Analysis</a:t>
            </a:r>
            <a:endParaRPr lang="en-GB" sz="900" dirty="0">
              <a:solidFill>
                <a:schemeClr val="tx1"/>
              </a:solidFill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256338" y="6553201"/>
            <a:ext cx="637306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/>
              <a:t>Electronic Supplementary Material 1 CONSORT diagram of the </a:t>
            </a:r>
            <a:r>
              <a:rPr lang="en-GB" sz="1400" i="1" dirty="0"/>
              <a:t>ADDITION-Europe</a:t>
            </a:r>
            <a:r>
              <a:rPr lang="en-GB" sz="1400" dirty="0"/>
              <a:t> trial</a:t>
            </a:r>
          </a:p>
        </p:txBody>
      </p:sp>
    </p:spTree>
    <p:extLst>
      <p:ext uri="{BB962C8B-B14F-4D97-AF65-F5344CB8AC3E}">
        <p14:creationId xmlns:p14="http://schemas.microsoft.com/office/powerpoint/2010/main" val="1343784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3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Black</dc:creator>
  <cp:lastModifiedBy>James Black</cp:lastModifiedBy>
  <cp:revision>2</cp:revision>
  <dcterms:created xsi:type="dcterms:W3CDTF">2006-08-16T00:00:00Z</dcterms:created>
  <dcterms:modified xsi:type="dcterms:W3CDTF">2013-09-25T11:39:09Z</dcterms:modified>
</cp:coreProperties>
</file>